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888"/>
    <p:restoredTop sz="95728"/>
  </p:normalViewPr>
  <p:slideViewPr>
    <p:cSldViewPr snapToGrid="0" snapToObjects="1" showGuides="1">
      <p:cViewPr varScale="1">
        <p:scale>
          <a:sx n="80" d="100"/>
          <a:sy n="80" d="100"/>
        </p:scale>
        <p:origin x="2864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804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17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52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711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72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059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486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153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525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098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459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B330B-07E4-A446-9F76-A4C7E618B98D}" type="datetimeFigureOut">
              <a:rPr lang="en-US" smtClean="0"/>
              <a:t>12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043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2FDCA04E-5841-A746-8727-E6B5475B5688}"/>
              </a:ext>
            </a:extLst>
          </p:cNvPr>
          <p:cNvGrpSpPr/>
          <p:nvPr/>
        </p:nvGrpSpPr>
        <p:grpSpPr>
          <a:xfrm>
            <a:off x="386797" y="624314"/>
            <a:ext cx="2232985" cy="4915184"/>
            <a:chOff x="3331165" y="313418"/>
            <a:chExt cx="2232985" cy="4915184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3CB517E7-051F-4549-8879-3A5478E9C9D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09557" y="313418"/>
              <a:ext cx="1554593" cy="553200"/>
            </a:xfrm>
            <a:prstGeom prst="rect">
              <a:avLst/>
            </a:prstGeom>
          </p:spPr>
        </p:pic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2B96C3D1-321E-204E-8FB0-C33D10DA08C1}"/>
                </a:ext>
              </a:extLst>
            </p:cNvPr>
            <p:cNvSpPr txBox="1"/>
            <p:nvPr/>
          </p:nvSpPr>
          <p:spPr>
            <a:xfrm>
              <a:off x="3592455" y="481172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DR1</a:t>
              </a:r>
            </a:p>
          </p:txBody>
        </p:sp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ACB1B161-F52F-174D-B32F-763A9AAA30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09557" y="914339"/>
              <a:ext cx="1554593" cy="553200"/>
            </a:xfrm>
            <a:prstGeom prst="rect">
              <a:avLst/>
            </a:prstGeom>
          </p:spPr>
        </p:pic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1912F286-9595-4249-90BF-C17D6312D6B9}"/>
                </a:ext>
              </a:extLst>
            </p:cNvPr>
            <p:cNvSpPr txBox="1"/>
            <p:nvPr/>
          </p:nvSpPr>
          <p:spPr>
            <a:xfrm>
              <a:off x="3592455" y="1083217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DR2</a:t>
              </a:r>
            </a:p>
          </p:txBody>
        </p:sp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8FF8C19C-D367-4748-88ED-3B911042494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09556" y="1900674"/>
              <a:ext cx="1554593" cy="534155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D913C32C-33F8-D144-ACF9-B8B7B6E6ED0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09557" y="1514073"/>
              <a:ext cx="1554593" cy="340067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0F9966F3-BD0B-2546-A54C-B2F90770E1B7}"/>
                </a:ext>
              </a:extLst>
            </p:cNvPr>
            <p:cNvSpPr/>
            <p:nvPr/>
          </p:nvSpPr>
          <p:spPr>
            <a:xfrm>
              <a:off x="4553447" y="1605690"/>
              <a:ext cx="856753" cy="1494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BC15BF67-5448-814D-8C0F-2B53091D3B5E}"/>
                </a:ext>
              </a:extLst>
            </p:cNvPr>
            <p:cNvSpPr/>
            <p:nvPr/>
          </p:nvSpPr>
          <p:spPr>
            <a:xfrm>
              <a:off x="4227317" y="1083420"/>
              <a:ext cx="1182883" cy="20351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F43D7990-8124-0F45-9F1C-21FEC32ADF49}"/>
                </a:ext>
              </a:extLst>
            </p:cNvPr>
            <p:cNvSpPr/>
            <p:nvPr/>
          </p:nvSpPr>
          <p:spPr>
            <a:xfrm>
              <a:off x="4296509" y="439616"/>
              <a:ext cx="1204664" cy="2533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F473F49B-7D53-9E46-8EFF-924B5712A38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09557" y="2958554"/>
              <a:ext cx="1554593" cy="422897"/>
            </a:xfrm>
            <a:prstGeom prst="rect">
              <a:avLst/>
            </a:prstGeom>
          </p:spPr>
        </p:pic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BC5FA46-110D-9F4C-8AD4-596F9B3EF391}"/>
                </a:ext>
              </a:extLst>
            </p:cNvPr>
            <p:cNvSpPr/>
            <p:nvPr/>
          </p:nvSpPr>
          <p:spPr>
            <a:xfrm>
              <a:off x="4390381" y="3065725"/>
              <a:ext cx="908450" cy="1494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361318E0-10D7-6D44-AB36-ACF2B92EAEBB}"/>
                </a:ext>
              </a:extLst>
            </p:cNvPr>
            <p:cNvSpPr txBox="1"/>
            <p:nvPr/>
          </p:nvSpPr>
          <p:spPr>
            <a:xfrm>
              <a:off x="3429000" y="2052391"/>
              <a:ext cx="5709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-ERK1/2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ACA52795-BE26-644D-9FF9-C8325EFA1789}"/>
                </a:ext>
              </a:extLst>
            </p:cNvPr>
            <p:cNvSpPr txBox="1"/>
            <p:nvPr/>
          </p:nvSpPr>
          <p:spPr>
            <a:xfrm>
              <a:off x="3601374" y="1588842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E2F1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46BD527C-3426-D240-872B-1741CADA391A}"/>
                </a:ext>
              </a:extLst>
            </p:cNvPr>
            <p:cNvSpPr/>
            <p:nvPr/>
          </p:nvSpPr>
          <p:spPr>
            <a:xfrm>
              <a:off x="4189548" y="2060186"/>
              <a:ext cx="1109283" cy="20351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id="{E362A082-3483-2E4B-BA36-023D61F0E11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09556" y="4111384"/>
              <a:ext cx="1554593" cy="561313"/>
            </a:xfrm>
            <a:prstGeom prst="rect">
              <a:avLst/>
            </a:prstGeom>
          </p:spPr>
        </p:pic>
        <p:pic>
          <p:nvPicPr>
            <p:cNvPr id="18" name="Image 17">
              <a:extLst>
                <a:ext uri="{FF2B5EF4-FFF2-40B4-BE49-F238E27FC236}">
                  <a16:creationId xmlns:a16="http://schemas.microsoft.com/office/drawing/2014/main" id="{EEC4CEC6-FA33-CD42-869B-DCDAD8099DA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998992" y="4732202"/>
              <a:ext cx="1554593" cy="496400"/>
            </a:xfrm>
            <a:prstGeom prst="rect">
              <a:avLst/>
            </a:prstGeom>
          </p:spPr>
        </p:pic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57B6B6C6-7CB1-E14B-9E0F-0B3CEA5F811D}"/>
                </a:ext>
              </a:extLst>
            </p:cNvPr>
            <p:cNvSpPr/>
            <p:nvPr/>
          </p:nvSpPr>
          <p:spPr>
            <a:xfrm>
              <a:off x="4246035" y="4259670"/>
              <a:ext cx="1147233" cy="19473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2884CCC0-1CB7-DB46-BF34-EA9D51091888}"/>
                </a:ext>
              </a:extLst>
            </p:cNvPr>
            <p:cNvSpPr/>
            <p:nvPr/>
          </p:nvSpPr>
          <p:spPr>
            <a:xfrm>
              <a:off x="4083071" y="4902691"/>
              <a:ext cx="1358898" cy="19473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E0B508CA-3E95-8E4A-BE0E-5941FF88C4A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014704" y="3438614"/>
              <a:ext cx="1549445" cy="613265"/>
            </a:xfrm>
            <a:prstGeom prst="rect">
              <a:avLst/>
            </a:prstGeom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346BB4E0-3722-F64D-B231-D4ACFAFF5DEB}"/>
                </a:ext>
              </a:extLst>
            </p:cNvPr>
            <p:cNvSpPr/>
            <p:nvPr/>
          </p:nvSpPr>
          <p:spPr>
            <a:xfrm>
              <a:off x="4093635" y="3647879"/>
              <a:ext cx="1358898" cy="19473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C0837B8A-09C5-974A-9B32-C1BC19B3BA7D}"/>
                </a:ext>
              </a:extLst>
            </p:cNvPr>
            <p:cNvSpPr txBox="1"/>
            <p:nvPr/>
          </p:nvSpPr>
          <p:spPr>
            <a:xfrm>
              <a:off x="3493068" y="3032737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/>
                <a:t>Survivin</a:t>
              </a:r>
              <a:endParaRPr lang="en-US" sz="800" dirty="0"/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1D2CC481-B63D-4C42-91F0-7A3E861C06CC}"/>
                </a:ext>
              </a:extLst>
            </p:cNvPr>
            <p:cNvSpPr txBox="1"/>
            <p:nvPr/>
          </p:nvSpPr>
          <p:spPr>
            <a:xfrm>
              <a:off x="3331165" y="3647879"/>
              <a:ext cx="6783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aspase 3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E45AC9A6-156A-F647-BD6A-6F3F3C3D5B25}"/>
                </a:ext>
              </a:extLst>
            </p:cNvPr>
            <p:cNvSpPr txBox="1"/>
            <p:nvPr/>
          </p:nvSpPr>
          <p:spPr>
            <a:xfrm>
              <a:off x="3331165" y="4217343"/>
              <a:ext cx="6783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/>
                <a:t>Cleaved</a:t>
              </a:r>
            </a:p>
            <a:p>
              <a:pPr algn="r"/>
              <a:r>
                <a:rPr lang="en-US" sz="800" dirty="0"/>
                <a:t>Caspase 3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57ECD16B-2C10-0643-BD22-E76DF6ABE3D4}"/>
                </a:ext>
              </a:extLst>
            </p:cNvPr>
            <p:cNvSpPr txBox="1"/>
            <p:nvPr/>
          </p:nvSpPr>
          <p:spPr>
            <a:xfrm>
              <a:off x="3487313" y="4909917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HSP60</a:t>
              </a:r>
            </a:p>
          </p:txBody>
        </p:sp>
        <p:pic>
          <p:nvPicPr>
            <p:cNvPr id="27" name="Image 26">
              <a:extLst>
                <a:ext uri="{FF2B5EF4-FFF2-40B4-BE49-F238E27FC236}">
                  <a16:creationId xmlns:a16="http://schemas.microsoft.com/office/drawing/2014/main" id="{8F3EC8ED-CBA4-6D4B-A5B3-57887561B33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009556" y="2479639"/>
              <a:ext cx="1548925" cy="428136"/>
            </a:xfrm>
            <a:prstGeom prst="rect">
              <a:avLst/>
            </a:prstGeom>
          </p:spPr>
        </p:pic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6B18F4A3-AC7D-1546-9D52-1AFF80D4327B}"/>
                </a:ext>
              </a:extLst>
            </p:cNvPr>
            <p:cNvSpPr/>
            <p:nvPr/>
          </p:nvSpPr>
          <p:spPr>
            <a:xfrm>
              <a:off x="4143982" y="2583115"/>
              <a:ext cx="1249285" cy="20431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72D4173B-4F4A-DE4C-AC51-5AE115DDE4C8}"/>
                </a:ext>
              </a:extLst>
            </p:cNvPr>
            <p:cNvSpPr txBox="1"/>
            <p:nvPr/>
          </p:nvSpPr>
          <p:spPr>
            <a:xfrm>
              <a:off x="3546268" y="2594279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ERK2</a:t>
              </a:r>
            </a:p>
          </p:txBody>
        </p:sp>
      </p:grpSp>
      <p:sp>
        <p:nvSpPr>
          <p:cNvPr id="30" name="ZoneTexte 29">
            <a:extLst>
              <a:ext uri="{FF2B5EF4-FFF2-40B4-BE49-F238E27FC236}">
                <a16:creationId xmlns:a16="http://schemas.microsoft.com/office/drawing/2014/main" id="{5DE17FD2-8116-3040-B5D0-2E858841D78A}"/>
              </a:ext>
            </a:extLst>
          </p:cNvPr>
          <p:cNvSpPr txBox="1"/>
          <p:nvPr/>
        </p:nvSpPr>
        <p:spPr>
          <a:xfrm>
            <a:off x="221382" y="119159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4B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FF7A70E9-ABF0-994D-AA30-2B58E097A3FC}"/>
              </a:ext>
            </a:extLst>
          </p:cNvPr>
          <p:cNvSpPr txBox="1"/>
          <p:nvPr/>
        </p:nvSpPr>
        <p:spPr>
          <a:xfrm>
            <a:off x="612399" y="5769966"/>
            <a:ext cx="2449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KMEL5 on FRC 3D-ECM</a:t>
            </a:r>
          </a:p>
        </p:txBody>
      </p: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604F1ED4-0DFB-2049-B483-A5C2E6C66C48}"/>
              </a:ext>
            </a:extLst>
          </p:cNvPr>
          <p:cNvGrpSpPr/>
          <p:nvPr/>
        </p:nvGrpSpPr>
        <p:grpSpPr>
          <a:xfrm>
            <a:off x="3580277" y="511809"/>
            <a:ext cx="2620717" cy="6893931"/>
            <a:chOff x="3475594" y="359066"/>
            <a:chExt cx="2620717" cy="6893931"/>
          </a:xfrm>
        </p:grpSpPr>
        <p:pic>
          <p:nvPicPr>
            <p:cNvPr id="33" name="Image 32">
              <a:extLst>
                <a:ext uri="{FF2B5EF4-FFF2-40B4-BE49-F238E27FC236}">
                  <a16:creationId xmlns:a16="http://schemas.microsoft.com/office/drawing/2014/main" id="{4B9775F2-D3D5-7542-80DD-BE1052CCAD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153985" y="6513804"/>
              <a:ext cx="1932462" cy="739193"/>
            </a:xfrm>
            <a:prstGeom prst="rect">
              <a:avLst/>
            </a:prstGeom>
          </p:spPr>
        </p:pic>
        <p:pic>
          <p:nvPicPr>
            <p:cNvPr id="34" name="Image 33">
              <a:extLst>
                <a:ext uri="{FF2B5EF4-FFF2-40B4-BE49-F238E27FC236}">
                  <a16:creationId xmlns:a16="http://schemas.microsoft.com/office/drawing/2014/main" id="{103C87E3-C941-BC43-8459-5C4F165703B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153985" y="5582638"/>
              <a:ext cx="1937722" cy="840014"/>
            </a:xfrm>
            <a:prstGeom prst="rect">
              <a:avLst/>
            </a:prstGeom>
          </p:spPr>
        </p:pic>
        <p:pic>
          <p:nvPicPr>
            <p:cNvPr id="35" name="Image 34">
              <a:extLst>
                <a:ext uri="{FF2B5EF4-FFF2-40B4-BE49-F238E27FC236}">
                  <a16:creationId xmlns:a16="http://schemas.microsoft.com/office/drawing/2014/main" id="{7736445D-E562-A04E-A2CB-24132BD2320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153985" y="2927203"/>
              <a:ext cx="1932462" cy="746113"/>
            </a:xfrm>
            <a:prstGeom prst="rect">
              <a:avLst/>
            </a:prstGeom>
          </p:spPr>
        </p:pic>
        <p:pic>
          <p:nvPicPr>
            <p:cNvPr id="36" name="Image 35">
              <a:extLst>
                <a:ext uri="{FF2B5EF4-FFF2-40B4-BE49-F238E27FC236}">
                  <a16:creationId xmlns:a16="http://schemas.microsoft.com/office/drawing/2014/main" id="{62DCA677-4CCF-6146-972F-2D76A097B14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149053" y="359066"/>
              <a:ext cx="1932462" cy="691199"/>
            </a:xfrm>
            <a:prstGeom prst="rect">
              <a:avLst/>
            </a:prstGeom>
          </p:spPr>
        </p:pic>
        <p:pic>
          <p:nvPicPr>
            <p:cNvPr id="37" name="Image 36">
              <a:extLst>
                <a:ext uri="{FF2B5EF4-FFF2-40B4-BE49-F238E27FC236}">
                  <a16:creationId xmlns:a16="http://schemas.microsoft.com/office/drawing/2014/main" id="{F03BDC02-6472-F84C-AACF-CCFDD07F8A33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144121" y="2076507"/>
              <a:ext cx="1932462" cy="774964"/>
            </a:xfrm>
            <a:prstGeom prst="rect">
              <a:avLst/>
            </a:prstGeom>
          </p:spPr>
        </p:pic>
        <p:pic>
          <p:nvPicPr>
            <p:cNvPr id="38" name="Image 37">
              <a:extLst>
                <a:ext uri="{FF2B5EF4-FFF2-40B4-BE49-F238E27FC236}">
                  <a16:creationId xmlns:a16="http://schemas.microsoft.com/office/drawing/2014/main" id="{FC3C6D0C-C362-7A44-A606-23C2F26B37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149053" y="1136081"/>
              <a:ext cx="1927530" cy="845350"/>
            </a:xfrm>
            <a:prstGeom prst="rect">
              <a:avLst/>
            </a:prstGeom>
          </p:spPr>
        </p:pic>
        <p:pic>
          <p:nvPicPr>
            <p:cNvPr id="39" name="Image 38">
              <a:extLst>
                <a:ext uri="{FF2B5EF4-FFF2-40B4-BE49-F238E27FC236}">
                  <a16:creationId xmlns:a16="http://schemas.microsoft.com/office/drawing/2014/main" id="{D0EC4655-BF97-CA4D-97EA-5C9D56B8C8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153985" y="3749048"/>
              <a:ext cx="1922598" cy="843187"/>
            </a:xfrm>
            <a:prstGeom prst="rect">
              <a:avLst/>
            </a:prstGeom>
          </p:spPr>
        </p:pic>
        <p:pic>
          <p:nvPicPr>
            <p:cNvPr id="40" name="Image 39">
              <a:extLst>
                <a:ext uri="{FF2B5EF4-FFF2-40B4-BE49-F238E27FC236}">
                  <a16:creationId xmlns:a16="http://schemas.microsoft.com/office/drawing/2014/main" id="{F071E210-EE73-894C-87C1-1330225EA351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153985" y="4685133"/>
              <a:ext cx="1942326" cy="802338"/>
            </a:xfrm>
            <a:prstGeom prst="rect">
              <a:avLst/>
            </a:prstGeom>
          </p:spPr>
        </p:pic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0822AA05-93EA-7A4F-B140-46C3BD65E24A}"/>
                </a:ext>
              </a:extLst>
            </p:cNvPr>
            <p:cNvSpPr/>
            <p:nvPr/>
          </p:nvSpPr>
          <p:spPr>
            <a:xfrm>
              <a:off x="4376418" y="2304848"/>
              <a:ext cx="1486722" cy="21943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E0B2197B-5E3F-4341-B84A-F9CB2783BB2D}"/>
                </a:ext>
              </a:extLst>
            </p:cNvPr>
            <p:cNvSpPr/>
            <p:nvPr/>
          </p:nvSpPr>
          <p:spPr>
            <a:xfrm>
              <a:off x="4366991" y="1502807"/>
              <a:ext cx="1486722" cy="21943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6B4D41F1-D024-E641-8A54-C398FB1B20CE}"/>
                </a:ext>
              </a:extLst>
            </p:cNvPr>
            <p:cNvSpPr/>
            <p:nvPr/>
          </p:nvSpPr>
          <p:spPr>
            <a:xfrm>
              <a:off x="4370594" y="591353"/>
              <a:ext cx="1486722" cy="27830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B29C6466-F4E0-5F4C-B1A8-5AEDBD3ED897}"/>
                </a:ext>
              </a:extLst>
            </p:cNvPr>
            <p:cNvSpPr/>
            <p:nvPr/>
          </p:nvSpPr>
          <p:spPr>
            <a:xfrm>
              <a:off x="4366991" y="3166454"/>
              <a:ext cx="1486722" cy="27830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E058EA3B-C160-DD4F-99F4-B7EEDB4F0562}"/>
                </a:ext>
              </a:extLst>
            </p:cNvPr>
            <p:cNvSpPr/>
            <p:nvPr/>
          </p:nvSpPr>
          <p:spPr>
            <a:xfrm>
              <a:off x="4366991" y="4030716"/>
              <a:ext cx="1486722" cy="2493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AFF2F224-0DA2-894F-9B07-1FBADAE1BC0E}"/>
                </a:ext>
              </a:extLst>
            </p:cNvPr>
            <p:cNvSpPr/>
            <p:nvPr/>
          </p:nvSpPr>
          <p:spPr>
            <a:xfrm>
              <a:off x="4315543" y="4932043"/>
              <a:ext cx="1538169" cy="2493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C6F0BFEE-7174-B54F-BA48-C394662F8C72}"/>
                </a:ext>
              </a:extLst>
            </p:cNvPr>
            <p:cNvSpPr/>
            <p:nvPr/>
          </p:nvSpPr>
          <p:spPr>
            <a:xfrm>
              <a:off x="4329619" y="5841589"/>
              <a:ext cx="1601098" cy="2493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6C88D6EE-F5DF-0E47-8626-01109AB6BB6E}"/>
                </a:ext>
              </a:extLst>
            </p:cNvPr>
            <p:cNvSpPr/>
            <p:nvPr/>
          </p:nvSpPr>
          <p:spPr>
            <a:xfrm>
              <a:off x="4315543" y="6770348"/>
              <a:ext cx="1644682" cy="32092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DC8DA3AC-105D-234C-932F-A8E039DD8148}"/>
                </a:ext>
              </a:extLst>
            </p:cNvPr>
            <p:cNvSpPr txBox="1"/>
            <p:nvPr/>
          </p:nvSpPr>
          <p:spPr>
            <a:xfrm>
              <a:off x="3592102" y="1506800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DR2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D1DC48BF-D7D7-4D4F-8E5A-4F286AA633AF}"/>
                </a:ext>
              </a:extLst>
            </p:cNvPr>
            <p:cNvSpPr txBox="1"/>
            <p:nvPr/>
          </p:nvSpPr>
          <p:spPr>
            <a:xfrm>
              <a:off x="3608092" y="658418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DDR1</a:t>
              </a:r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E5D3FFDD-98AE-3B4C-8798-B1DFC09C3478}"/>
                </a:ext>
              </a:extLst>
            </p:cNvPr>
            <p:cNvSpPr txBox="1"/>
            <p:nvPr/>
          </p:nvSpPr>
          <p:spPr>
            <a:xfrm>
              <a:off x="3608092" y="2309223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E2F1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2406E71B-65DB-754B-9CEF-C41020DE8475}"/>
                </a:ext>
              </a:extLst>
            </p:cNvPr>
            <p:cNvSpPr txBox="1"/>
            <p:nvPr/>
          </p:nvSpPr>
          <p:spPr>
            <a:xfrm>
              <a:off x="3475952" y="3197882"/>
              <a:ext cx="6431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-ERK1/2</a:t>
              </a:r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51370921-59A9-C144-A8E9-5133E119B6AC}"/>
                </a:ext>
              </a:extLst>
            </p:cNvPr>
            <p:cNvSpPr txBox="1"/>
            <p:nvPr/>
          </p:nvSpPr>
          <p:spPr>
            <a:xfrm>
              <a:off x="3651605" y="4048214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ERK2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7D72CD71-DF25-8949-98D7-D6015822B38D}"/>
                </a:ext>
              </a:extLst>
            </p:cNvPr>
            <p:cNvSpPr txBox="1"/>
            <p:nvPr/>
          </p:nvSpPr>
          <p:spPr>
            <a:xfrm>
              <a:off x="3547979" y="4965267"/>
              <a:ext cx="5501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/>
                <a:t>Survivin</a:t>
              </a:r>
              <a:endParaRPr lang="en-US" sz="800" dirty="0"/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6C946DFA-C02D-5C49-AE3B-97F1FB45D020}"/>
                </a:ext>
              </a:extLst>
            </p:cNvPr>
            <p:cNvSpPr txBox="1"/>
            <p:nvPr/>
          </p:nvSpPr>
          <p:spPr>
            <a:xfrm>
              <a:off x="3483858" y="5858566"/>
              <a:ext cx="6783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aspase 3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11B943DB-0D0A-D047-9C4D-65439173AED5}"/>
                </a:ext>
              </a:extLst>
            </p:cNvPr>
            <p:cNvSpPr txBox="1"/>
            <p:nvPr/>
          </p:nvSpPr>
          <p:spPr>
            <a:xfrm>
              <a:off x="3475594" y="6817423"/>
              <a:ext cx="6783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leaved</a:t>
              </a:r>
            </a:p>
            <a:p>
              <a:r>
                <a:rPr lang="en-US" sz="800" dirty="0"/>
                <a:t>Caspase 3</a:t>
              </a:r>
            </a:p>
          </p:txBody>
        </p:sp>
      </p:grpSp>
      <p:sp>
        <p:nvSpPr>
          <p:cNvPr id="57" name="ZoneTexte 56">
            <a:extLst>
              <a:ext uri="{FF2B5EF4-FFF2-40B4-BE49-F238E27FC236}">
                <a16:creationId xmlns:a16="http://schemas.microsoft.com/office/drawing/2014/main" id="{4899E23E-79CB-ED45-9DA1-1034D9C85420}"/>
              </a:ext>
            </a:extLst>
          </p:cNvPr>
          <p:cNvSpPr txBox="1"/>
          <p:nvPr/>
        </p:nvSpPr>
        <p:spPr>
          <a:xfrm>
            <a:off x="4009964" y="7638785"/>
            <a:ext cx="2533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KMEL5 on MAF 3D-ECM</a:t>
            </a:r>
          </a:p>
        </p:txBody>
      </p:sp>
    </p:spTree>
    <p:extLst>
      <p:ext uri="{BB962C8B-B14F-4D97-AF65-F5344CB8AC3E}">
        <p14:creationId xmlns:p14="http://schemas.microsoft.com/office/powerpoint/2010/main" val="75430326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7</TotalTime>
  <Words>33</Words>
  <Application>Microsoft Macintosh PowerPoint</Application>
  <PresentationFormat>Format A4 (210 x 297 mm)</PresentationFormat>
  <Paragraphs>2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lona Berestjuk</dc:creator>
  <cp:lastModifiedBy>Marcel Deckert</cp:lastModifiedBy>
  <cp:revision>70</cp:revision>
  <dcterms:created xsi:type="dcterms:W3CDTF">2020-12-20T01:36:34Z</dcterms:created>
  <dcterms:modified xsi:type="dcterms:W3CDTF">2021-12-02T09:34:09Z</dcterms:modified>
</cp:coreProperties>
</file>